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6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57" d="100"/>
          <a:sy n="57" d="100"/>
        </p:scale>
        <p:origin x="2587" y="67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6684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34863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48257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07267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78351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71331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34262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75637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0103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4331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69706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45935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4496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9364" y="8906361"/>
            <a:ext cx="682577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7. The Δ(SNP-index) plot obtained by subtraction of rust resistant pool SNP-index from rust susceptible pool SNP-index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tistical confidence intervals under the null hypothesis of no QTL are shown (green: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; orange: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1)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0" name="Group 9"/>
          <p:cNvGrpSpPr/>
          <p:nvPr/>
        </p:nvGrpSpPr>
        <p:grpSpPr>
          <a:xfrm>
            <a:off x="0" y="-14310"/>
            <a:ext cx="6835140" cy="8742499"/>
            <a:chOff x="0" y="-14310"/>
            <a:chExt cx="6835140" cy="8742499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77481"/>
            <a:stretch/>
          </p:blipFill>
          <p:spPr>
            <a:xfrm>
              <a:off x="9364" y="0"/>
              <a:ext cx="2238062" cy="7455422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5074" r="2371" b="66247"/>
            <a:stretch/>
          </p:blipFill>
          <p:spPr>
            <a:xfrm>
              <a:off x="4553151" y="4975087"/>
              <a:ext cx="2241641" cy="2516429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889" r="52148" b="83086"/>
            <a:stretch/>
          </p:blipFill>
          <p:spPr>
            <a:xfrm>
              <a:off x="0" y="7467179"/>
              <a:ext cx="2282190" cy="1261010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889" t="16321" r="52148"/>
            <a:stretch/>
          </p:blipFill>
          <p:spPr>
            <a:xfrm>
              <a:off x="2270961" y="-14310"/>
              <a:ext cx="2282190" cy="6238622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074" r="27482" b="66491"/>
            <a:stretch/>
          </p:blipFill>
          <p:spPr>
            <a:xfrm>
              <a:off x="2296751" y="6218061"/>
              <a:ext cx="2230609" cy="2498237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074" t="33315" r="27482"/>
            <a:stretch/>
          </p:blipFill>
          <p:spPr>
            <a:xfrm>
              <a:off x="4604531" y="-14310"/>
              <a:ext cx="2230609" cy="4971648"/>
            </a:xfrm>
            <a:prstGeom prst="rect">
              <a:avLst/>
            </a:prstGeom>
          </p:spPr>
        </p:pic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81</TotalTime>
  <Words>46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ngh, Vikas (ICRISAT-IN)</dc:creator>
  <cp:lastModifiedBy>Pandey</cp:lastModifiedBy>
  <cp:revision>90</cp:revision>
  <dcterms:created xsi:type="dcterms:W3CDTF">2015-04-20T11:32:42Z</dcterms:created>
  <dcterms:modified xsi:type="dcterms:W3CDTF">2016-09-26T10:47:39Z</dcterms:modified>
</cp:coreProperties>
</file>